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100"/>
  </p:normalViewPr>
  <p:slideViewPr>
    <p:cSldViewPr snapToGrid="0" snapToObjects="1">
      <p:cViewPr varScale="1">
        <p:scale>
          <a:sx n="88" d="100"/>
          <a:sy n="88" d="100"/>
        </p:scale>
        <p:origin x="9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C941D4-86B0-C44B-9AAE-BC798EE1E5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64B6174-E3DD-E949-ACD9-022AE5F62E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80C650-359F-614A-854E-07E8DC68D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DFFF6A-2C06-014F-B3B5-DA067E714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DC4126-8C95-4C46-8633-9F8A0903E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776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0B380-2E71-F343-8723-16F2CE152F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91781D-5D14-4F4C-8721-57AB6165E2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63BFE2-5578-3646-B6DE-4AA66715A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DD0D13-9A53-1040-9B75-1BA1C445B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7C8A36-01F6-5B48-A246-6808912B4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958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DEEFF7-B3D5-9F4E-867A-56E06E3A79B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B917F5-F51D-2E49-95AB-EF3A94091A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64403B-544E-FE42-9454-82294F5F3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30D566-247D-B34F-8D36-5472FCECD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53AF4C-28E5-9D4A-A351-F6CBB42CF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734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CC66E4-8718-2246-839F-61B2DC6BC5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E423A1-0640-2B43-8E84-2202BBC5A7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811F50-8B5F-6044-ABF3-32883D5C7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3FB377-3C45-4B4D-B359-3E06C7120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DC0A71-5EA6-754C-B845-474DD53EA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696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4C4B4A-EF4D-0649-8AB0-E61D6BE275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70845A-7C27-2141-B532-183B20582F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3EA076-120E-B14D-BABA-E959B0FDB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FB7996-D845-C248-B4DA-3DF3A1E08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DFB932-268C-7047-94DE-E7E90E076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214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2E3AB4-5219-CC46-B48D-34D19C99D7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5DE004-B885-0048-9E48-263F4FD0BF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8B213B-E80A-CE4D-AF22-4B62B15B04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31A678-6BCE-EB42-818E-D08DB97DB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3C8937-2C82-9C41-9F12-EE889C850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40F345-6BC3-4C46-B4EB-15EECDA69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573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2528B7-CCFD-B042-B44C-65DEE74E77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520AF1-EF0D-264C-83EF-25DC05F8E3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444BB6-B6A6-8D47-BD8F-7D0F179209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3FA97F-6643-E644-B510-68CE662A84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19A14D-16A3-1D46-9767-D9A1D6122F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508095-8354-0B4A-B050-C242DE141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61BB11-61D8-EA4C-9D17-B795426BD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5BAFBA-4C1B-3841-83CB-4319EFC22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764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A7D979-45DF-544B-B2D7-C6F79DEEB9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5D42A0-79A3-D148-8330-78A584C86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0B72F1-8302-4742-973B-3F43DCA37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9F574F-2190-F24C-B9A6-5FEC80DBB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505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CE2653-5633-4B46-BF1E-95BFD4CC4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A56B71-A858-F14B-95F5-863CF7204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399B08-652A-B345-955C-D13EBE7D8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564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5F39C2-58B7-FC48-B51B-C661B59DD2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83AA66-FD23-344F-8BE4-416B56C16D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5C690D-FD6F-B744-AEB2-E83CD8FD0F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1136CB-A613-5A45-B558-29BDC487D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8B5C11-0C5E-A24C-9F0B-2CFFFF7CC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709F6E-9BC8-064B-AE7B-3A736A1C2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008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A1F3C9-615E-8943-AFC0-27F4E13E20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4C29D1-2DF7-E447-909C-8C868D2193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F4B840-E02C-414D-8EE9-15F1E03B88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0D132D-E9B8-0542-9FD3-C7283E3A4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1E1F20-413C-5744-96AB-982A66A0D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436DF7-DC1C-CC45-A6E7-B13CA6DE1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003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7F248D-BCC4-E847-8556-53B4150329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A5B787-5CE6-6049-A23A-1BFBE17802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FC295A-AB42-4645-91F7-CC8521A0AF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3EB2C7-09D6-E74C-8B1E-60E87D0833F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08451-CD1E-3248-BB3E-324EF83B19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41C6FA-62F1-AA42-8D91-1272A78CB3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2B3A8-0E18-B143-995D-13FB1B6BE3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340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8">
            <a:extLst>
              <a:ext uri="{FF2B5EF4-FFF2-40B4-BE49-F238E27FC236}">
                <a16:creationId xmlns:a16="http://schemas.microsoft.com/office/drawing/2014/main" id="{F1661996-E297-584D-B509-385CC900DBC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345" y="137928"/>
            <a:ext cx="2857500" cy="15494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89F5178-824A-5542-96B6-707D9808DFC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2424" t="-14811" r="-3003" b="-4037"/>
          <a:stretch/>
        </p:blipFill>
        <p:spPr>
          <a:xfrm>
            <a:off x="7786372" y="2059410"/>
            <a:ext cx="2902489" cy="2475327"/>
          </a:xfrm>
          <a:prstGeom prst="rect">
            <a:avLst/>
          </a:prstGeom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C5F6C50-F963-F045-858C-791D15F72B1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6378" t="-5577" r="-17234" b="-14336"/>
          <a:stretch/>
        </p:blipFill>
        <p:spPr>
          <a:xfrm>
            <a:off x="7659059" y="4015998"/>
            <a:ext cx="3029802" cy="3125338"/>
          </a:xfrm>
          <a:prstGeom prst="rect">
            <a:avLst/>
          </a:prstGeom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026D326-BB0B-964B-B220-DF23930D7F6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7359" t="-2349" r="-7639" b="-14520"/>
          <a:stretch/>
        </p:blipFill>
        <p:spPr>
          <a:xfrm>
            <a:off x="7717074" y="310484"/>
            <a:ext cx="2818670" cy="2330350"/>
          </a:xfrm>
          <a:prstGeom prst="rect">
            <a:avLst/>
          </a:prstGeom>
          <a:ln>
            <a:noFill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4F41641-3314-2743-9D98-4BA61E05725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-4664" t="-6424" r="-5889" b="-4272"/>
          <a:stretch/>
        </p:blipFill>
        <p:spPr>
          <a:xfrm>
            <a:off x="3844265" y="2991171"/>
            <a:ext cx="3495998" cy="3753754"/>
          </a:xfrm>
          <a:prstGeom prst="rect">
            <a:avLst/>
          </a:prstGeom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FC9357D-BB82-EF4B-8FB6-07ADDE154F6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6155" t="-20967" r="-2359" b="-10380"/>
          <a:stretch/>
        </p:blipFill>
        <p:spPr>
          <a:xfrm>
            <a:off x="3985395" y="1625748"/>
            <a:ext cx="2577113" cy="1651422"/>
          </a:xfrm>
          <a:prstGeom prst="rect">
            <a:avLst/>
          </a:prstGeom>
          <a:ln>
            <a:noFill/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DFAB5127-C3EE-A045-9B1E-766E055FAB0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-15187" t="-8310" r="-6858" b="-2888"/>
          <a:stretch/>
        </p:blipFill>
        <p:spPr>
          <a:xfrm>
            <a:off x="3552344" y="80854"/>
            <a:ext cx="3487411" cy="1722917"/>
          </a:xfrm>
          <a:prstGeom prst="rect">
            <a:avLst/>
          </a:prstGeom>
          <a:ln>
            <a:noFill/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E7CFFD22-9214-BB4A-A7C0-4CE6302D6E3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-5809" t="-2402" r="-3538" b="-15940"/>
          <a:stretch/>
        </p:blipFill>
        <p:spPr>
          <a:xfrm>
            <a:off x="247742" y="2802888"/>
            <a:ext cx="3166281" cy="2219926"/>
          </a:xfrm>
          <a:prstGeom prst="rect">
            <a:avLst/>
          </a:prstGeom>
          <a:ln>
            <a:noFill/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974F77E-5CCC-154D-983F-D46586CB928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5466" t="-19014" r="-2743" b="-10388"/>
          <a:stretch/>
        </p:blipFill>
        <p:spPr>
          <a:xfrm>
            <a:off x="521589" y="4391240"/>
            <a:ext cx="2556090" cy="1446177"/>
          </a:xfrm>
          <a:prstGeom prst="rect">
            <a:avLst/>
          </a:prstGeom>
          <a:ln>
            <a:noFill/>
          </a:ln>
        </p:spPr>
      </p:pic>
      <p:sp>
        <p:nvSpPr>
          <p:cNvPr id="31" name="ZoneTexte 5">
            <a:extLst>
              <a:ext uri="{FF2B5EF4-FFF2-40B4-BE49-F238E27FC236}">
                <a16:creationId xmlns:a16="http://schemas.microsoft.com/office/drawing/2014/main" id="{1EF0B647-C0C4-944E-91CA-94605AC57098}"/>
              </a:ext>
            </a:extLst>
          </p:cNvPr>
          <p:cNvSpPr txBox="1"/>
          <p:nvPr/>
        </p:nvSpPr>
        <p:spPr>
          <a:xfrm>
            <a:off x="6930270" y="-27124"/>
            <a:ext cx="1161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E</a:t>
            </a:r>
            <a:endParaRPr lang="fr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AA03E81-725E-904F-97D3-5C6BFF209DB8}"/>
              </a:ext>
            </a:extLst>
          </p:cNvPr>
          <p:cNvSpPr/>
          <p:nvPr/>
        </p:nvSpPr>
        <p:spPr>
          <a:xfrm>
            <a:off x="708926" y="566414"/>
            <a:ext cx="186371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6D77C6B0-A333-9540-A4E0-DB23F8D69900}"/>
              </a:ext>
            </a:extLst>
          </p:cNvPr>
          <p:cNvSpPr/>
          <p:nvPr/>
        </p:nvSpPr>
        <p:spPr>
          <a:xfrm>
            <a:off x="4615968" y="4565212"/>
            <a:ext cx="186371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2F8C25A-5D34-1446-987E-F93E87137E97}"/>
              </a:ext>
            </a:extLst>
          </p:cNvPr>
          <p:cNvSpPr/>
          <p:nvPr/>
        </p:nvSpPr>
        <p:spPr>
          <a:xfrm>
            <a:off x="4660404" y="3959678"/>
            <a:ext cx="186371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AD333688-CB9B-ED4C-AA5A-D7EB36234F8F}"/>
              </a:ext>
            </a:extLst>
          </p:cNvPr>
          <p:cNvSpPr/>
          <p:nvPr/>
        </p:nvSpPr>
        <p:spPr>
          <a:xfrm>
            <a:off x="772030" y="3803017"/>
            <a:ext cx="1715826" cy="35318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C92215EE-8DF3-7548-B075-FAD7114FF76E}"/>
              </a:ext>
            </a:extLst>
          </p:cNvPr>
          <p:cNvSpPr/>
          <p:nvPr/>
        </p:nvSpPr>
        <p:spPr>
          <a:xfrm>
            <a:off x="4309591" y="2170646"/>
            <a:ext cx="1863719" cy="2849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147776D5-5FBB-8942-94D7-3F0853516D33}"/>
              </a:ext>
            </a:extLst>
          </p:cNvPr>
          <p:cNvSpPr/>
          <p:nvPr/>
        </p:nvSpPr>
        <p:spPr>
          <a:xfrm>
            <a:off x="4309590" y="2479560"/>
            <a:ext cx="1863719" cy="2849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74E0B3DC-3BE5-1041-B7F9-8657DE5B4970}"/>
              </a:ext>
            </a:extLst>
          </p:cNvPr>
          <p:cNvSpPr/>
          <p:nvPr/>
        </p:nvSpPr>
        <p:spPr>
          <a:xfrm>
            <a:off x="8104630" y="847110"/>
            <a:ext cx="1863719" cy="2849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405D7AC2-5B5E-E240-9D36-D9F49E707FCE}"/>
              </a:ext>
            </a:extLst>
          </p:cNvPr>
          <p:cNvSpPr/>
          <p:nvPr/>
        </p:nvSpPr>
        <p:spPr>
          <a:xfrm>
            <a:off x="8104630" y="1636961"/>
            <a:ext cx="1863719" cy="2849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398F9235-92C7-EC49-AFEE-B96BFDB9E1D4}"/>
              </a:ext>
            </a:extLst>
          </p:cNvPr>
          <p:cNvSpPr/>
          <p:nvPr/>
        </p:nvSpPr>
        <p:spPr>
          <a:xfrm>
            <a:off x="8372580" y="3482510"/>
            <a:ext cx="1863719" cy="2849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7DA5DF98-0C53-B747-9B3D-4913941D2771}"/>
              </a:ext>
            </a:extLst>
          </p:cNvPr>
          <p:cNvSpPr/>
          <p:nvPr/>
        </p:nvSpPr>
        <p:spPr>
          <a:xfrm>
            <a:off x="8372579" y="2993822"/>
            <a:ext cx="1863719" cy="2849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352D349-5FFE-3F40-877B-F4D072483EB8}"/>
              </a:ext>
            </a:extLst>
          </p:cNvPr>
          <p:cNvSpPr/>
          <p:nvPr/>
        </p:nvSpPr>
        <p:spPr>
          <a:xfrm>
            <a:off x="8242100" y="5037596"/>
            <a:ext cx="1863719" cy="2849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64CBC7A7-0F6C-5144-84A4-10E7D99682B7}"/>
              </a:ext>
            </a:extLst>
          </p:cNvPr>
          <p:cNvSpPr/>
          <p:nvPr/>
        </p:nvSpPr>
        <p:spPr>
          <a:xfrm>
            <a:off x="8218603" y="5742523"/>
            <a:ext cx="1863719" cy="2849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7A473344-C32D-6B42-B057-B5B4808C1990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523" y="1714472"/>
            <a:ext cx="2362200" cy="1117600"/>
          </a:xfrm>
          <a:prstGeom prst="rect">
            <a:avLst/>
          </a:prstGeom>
        </p:spPr>
      </p:pic>
      <p:sp>
        <p:nvSpPr>
          <p:cNvPr id="52" name="Rectangle 51">
            <a:extLst>
              <a:ext uri="{FF2B5EF4-FFF2-40B4-BE49-F238E27FC236}">
                <a16:creationId xmlns:a16="http://schemas.microsoft.com/office/drawing/2014/main" id="{400BD6F0-09A9-EA4C-8007-128AA275AFF4}"/>
              </a:ext>
            </a:extLst>
          </p:cNvPr>
          <p:cNvSpPr/>
          <p:nvPr/>
        </p:nvSpPr>
        <p:spPr>
          <a:xfrm>
            <a:off x="705883" y="2276769"/>
            <a:ext cx="1863719" cy="346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AD2A5B4-0C81-E448-8A09-6E9D3B944A11}"/>
              </a:ext>
            </a:extLst>
          </p:cNvPr>
          <p:cNvSpPr txBox="1"/>
          <p:nvPr/>
        </p:nvSpPr>
        <p:spPr>
          <a:xfrm>
            <a:off x="2945028" y="2247765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EEF3061-7CD5-D74E-925C-17BB24CEA632}"/>
              </a:ext>
            </a:extLst>
          </p:cNvPr>
          <p:cNvSpPr txBox="1"/>
          <p:nvPr/>
        </p:nvSpPr>
        <p:spPr>
          <a:xfrm>
            <a:off x="3113212" y="635629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a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313C2FD-1EF7-494B-97B0-6A9A17F5A0D4}"/>
              </a:ext>
            </a:extLst>
          </p:cNvPr>
          <p:cNvSpPr txBox="1"/>
          <p:nvPr/>
        </p:nvSpPr>
        <p:spPr>
          <a:xfrm>
            <a:off x="3237677" y="3884662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2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C6021EA-410A-7046-82FE-95F3CA674A4C}"/>
              </a:ext>
            </a:extLst>
          </p:cNvPr>
          <p:cNvSpPr txBox="1"/>
          <p:nvPr/>
        </p:nvSpPr>
        <p:spPr>
          <a:xfrm>
            <a:off x="3061808" y="5027423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4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3AE51B7-DF5E-9F42-BA20-856228B4ECC3}"/>
              </a:ext>
            </a:extLst>
          </p:cNvPr>
          <p:cNvSpPr txBox="1"/>
          <p:nvPr/>
        </p:nvSpPr>
        <p:spPr>
          <a:xfrm>
            <a:off x="6808841" y="835781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pl47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E0C304F-23D3-8A45-B020-44471A03291C}"/>
              </a:ext>
            </a:extLst>
          </p:cNvPr>
          <p:cNvSpPr txBox="1"/>
          <p:nvPr/>
        </p:nvSpPr>
        <p:spPr>
          <a:xfrm>
            <a:off x="6530830" y="2180879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8486E13-AF51-574F-8636-EF84901B73D8}"/>
              </a:ext>
            </a:extLst>
          </p:cNvPr>
          <p:cNvSpPr txBox="1"/>
          <p:nvPr/>
        </p:nvSpPr>
        <p:spPr>
          <a:xfrm>
            <a:off x="6524123" y="2462342"/>
            <a:ext cx="5245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rs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CF4271A-52E2-0042-81EC-51C318E7EDEF}"/>
              </a:ext>
            </a:extLst>
          </p:cNvPr>
          <p:cNvSpPr txBox="1"/>
          <p:nvPr/>
        </p:nvSpPr>
        <p:spPr>
          <a:xfrm>
            <a:off x="6931877" y="3994285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rs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5E152FA-BAD3-9843-BB59-605C85835B7F}"/>
              </a:ext>
            </a:extLst>
          </p:cNvPr>
          <p:cNvSpPr txBox="1"/>
          <p:nvPr/>
        </p:nvSpPr>
        <p:spPr>
          <a:xfrm>
            <a:off x="7005193" y="4617732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ph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1E8B0DD-EB74-204A-AF0D-26B67B35C2A2}"/>
              </a:ext>
            </a:extLst>
          </p:cNvPr>
          <p:cNvSpPr txBox="1"/>
          <p:nvPr/>
        </p:nvSpPr>
        <p:spPr>
          <a:xfrm>
            <a:off x="10392145" y="81758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ns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1EA9C42-B5D2-BE4D-ABD4-3C39A9E321E2}"/>
              </a:ext>
            </a:extLst>
          </p:cNvPr>
          <p:cNvSpPr txBox="1"/>
          <p:nvPr/>
        </p:nvSpPr>
        <p:spPr>
          <a:xfrm>
            <a:off x="10528274" y="2978442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gdh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E25E9BD-B8B1-574A-AF6E-2C2FD6F04730}"/>
              </a:ext>
            </a:extLst>
          </p:cNvPr>
          <p:cNvSpPr txBox="1"/>
          <p:nvPr/>
        </p:nvSpPr>
        <p:spPr>
          <a:xfrm>
            <a:off x="10557568" y="3443835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at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6893BBE-5D94-E448-B723-E8EE90DC94B1}"/>
              </a:ext>
            </a:extLst>
          </p:cNvPr>
          <p:cNvSpPr txBox="1"/>
          <p:nvPr/>
        </p:nvSpPr>
        <p:spPr>
          <a:xfrm>
            <a:off x="10269228" y="1643662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Ebp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D2FD591-CBC9-074D-8698-E2DB201A7B9D}"/>
              </a:ext>
            </a:extLst>
          </p:cNvPr>
          <p:cNvSpPr txBox="1"/>
          <p:nvPr/>
        </p:nvSpPr>
        <p:spPr>
          <a:xfrm>
            <a:off x="10225402" y="5731329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Ebp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59BCCFB-2CA2-9248-979E-CB51F0749823}"/>
              </a:ext>
            </a:extLst>
          </p:cNvPr>
          <p:cNvSpPr txBox="1"/>
          <p:nvPr/>
        </p:nvSpPr>
        <p:spPr>
          <a:xfrm>
            <a:off x="10247226" y="5018295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d7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88943C0-E00C-6A4F-8072-82399BCF1A3A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H="1">
            <a:off x="1186386" y="4904323"/>
            <a:ext cx="876300" cy="2552700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473D378F-CB65-DD42-8C8C-EE37CD31F3E0}"/>
              </a:ext>
            </a:extLst>
          </p:cNvPr>
          <p:cNvSpPr txBox="1"/>
          <p:nvPr/>
        </p:nvSpPr>
        <p:spPr>
          <a:xfrm>
            <a:off x="2923723" y="5815208"/>
            <a:ext cx="15209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 (second membrane, not shown in Figure 6E)</a:t>
            </a:r>
          </a:p>
        </p:txBody>
      </p:sp>
    </p:spTree>
    <p:extLst>
      <p:ext uri="{BB962C8B-B14F-4D97-AF65-F5344CB8AC3E}">
        <p14:creationId xmlns:p14="http://schemas.microsoft.com/office/powerpoint/2010/main" val="264940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Macintosh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Microsoft Office User</cp:lastModifiedBy>
  <cp:revision>1</cp:revision>
  <dcterms:created xsi:type="dcterms:W3CDTF">2025-12-05T15:03:45Z</dcterms:created>
  <dcterms:modified xsi:type="dcterms:W3CDTF">2025-12-05T15:04:01Z</dcterms:modified>
  <cp:category/>
</cp:coreProperties>
</file>